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306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D8D62"/>
    <a:srgbClr val="66C2A5"/>
    <a:srgbClr val="A6A6A6"/>
    <a:srgbClr val="D9D9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846" autoAdjust="0"/>
    <p:restoredTop sz="94660"/>
  </p:normalViewPr>
  <p:slideViewPr>
    <p:cSldViewPr snapToGrid="0">
      <p:cViewPr varScale="1">
        <p:scale>
          <a:sx n="84" d="100"/>
          <a:sy n="84" d="100"/>
        </p:scale>
        <p:origin x="355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1B5E7-D345-4F47-8C89-F732F06BB55F}" type="datetimeFigureOut">
              <a:rPr lang="en-US" smtClean="0"/>
              <a:t>10/3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F8426-36B2-4553-9D11-553EA751A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3384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1B5E7-D345-4F47-8C89-F732F06BB55F}" type="datetimeFigureOut">
              <a:rPr lang="en-US" smtClean="0"/>
              <a:t>10/3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F8426-36B2-4553-9D11-553EA751A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36230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1B5E7-D345-4F47-8C89-F732F06BB55F}" type="datetimeFigureOut">
              <a:rPr lang="en-US" smtClean="0"/>
              <a:t>10/3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F8426-36B2-4553-9D11-553EA751A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15030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1B5E7-D345-4F47-8C89-F732F06BB55F}" type="datetimeFigureOut">
              <a:rPr lang="en-US" smtClean="0"/>
              <a:t>10/3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F8426-36B2-4553-9D11-553EA751A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27708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1B5E7-D345-4F47-8C89-F732F06BB55F}" type="datetimeFigureOut">
              <a:rPr lang="en-US" smtClean="0"/>
              <a:t>10/3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F8426-36B2-4553-9D11-553EA751A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53427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1B5E7-D345-4F47-8C89-F732F06BB55F}" type="datetimeFigureOut">
              <a:rPr lang="en-US" smtClean="0"/>
              <a:t>10/3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F8426-36B2-4553-9D11-553EA751A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60330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1B5E7-D345-4F47-8C89-F732F06BB55F}" type="datetimeFigureOut">
              <a:rPr lang="en-US" smtClean="0"/>
              <a:t>10/3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F8426-36B2-4553-9D11-553EA751A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0258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1B5E7-D345-4F47-8C89-F732F06BB55F}" type="datetimeFigureOut">
              <a:rPr lang="en-US" smtClean="0"/>
              <a:t>10/3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F8426-36B2-4553-9D11-553EA751A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2415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1B5E7-D345-4F47-8C89-F732F06BB55F}" type="datetimeFigureOut">
              <a:rPr lang="en-US" smtClean="0"/>
              <a:t>10/3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F8426-36B2-4553-9D11-553EA751A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8253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1B5E7-D345-4F47-8C89-F732F06BB55F}" type="datetimeFigureOut">
              <a:rPr lang="en-US" smtClean="0"/>
              <a:t>10/3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F8426-36B2-4553-9D11-553EA751A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13788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1B5E7-D345-4F47-8C89-F732F06BB55F}" type="datetimeFigureOut">
              <a:rPr lang="en-US" smtClean="0"/>
              <a:t>10/3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F8426-36B2-4553-9D11-553EA751A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0587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31B5E7-D345-4F47-8C89-F732F06BB55F}" type="datetimeFigureOut">
              <a:rPr lang="en-US" smtClean="0"/>
              <a:t>10/3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CF8426-36B2-4553-9D11-553EA751A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254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13F13A3E-D246-CABF-9010-006B57DA6E99}"/>
              </a:ext>
            </a:extLst>
          </p:cNvPr>
          <p:cNvGrpSpPr/>
          <p:nvPr/>
        </p:nvGrpSpPr>
        <p:grpSpPr>
          <a:xfrm>
            <a:off x="1271660" y="646139"/>
            <a:ext cx="4460955" cy="4325361"/>
            <a:chOff x="-71396" y="-357023"/>
            <a:chExt cx="5188819" cy="386278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36AD0C7C-8346-6154-324D-04E7A2F01C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rcRect l="68907" t="70830" r="10236" b="11980"/>
            <a:stretch/>
          </p:blipFill>
          <p:spPr>
            <a:xfrm>
              <a:off x="2455887" y="1150603"/>
              <a:ext cx="1496291" cy="1157509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85A45BB4-7D22-E00C-475D-4FDF37BB88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rcRect l="20141" t="75944" r="56752" b="5542"/>
            <a:stretch/>
          </p:blipFill>
          <p:spPr>
            <a:xfrm>
              <a:off x="2457298" y="2348248"/>
              <a:ext cx="1496291" cy="1157509"/>
            </a:xfrm>
            <a:prstGeom prst="rect">
              <a:avLst/>
            </a:prstGeom>
          </p:spPr>
        </p:pic>
        <p:sp>
          <p:nvSpPr>
            <p:cNvPr id="5" name="TextBox 70">
              <a:extLst>
                <a:ext uri="{FF2B5EF4-FFF2-40B4-BE49-F238E27FC236}">
                  <a16:creationId xmlns:a16="http://schemas.microsoft.com/office/drawing/2014/main" id="{CED4B00F-BAAD-71F6-3817-7A367A91FBBB}"/>
                </a:ext>
              </a:extLst>
            </p:cNvPr>
            <p:cNvSpPr txBox="1"/>
            <p:nvPr/>
          </p:nvSpPr>
          <p:spPr>
            <a:xfrm rot="16200000">
              <a:off x="2352603" y="300781"/>
              <a:ext cx="1145331" cy="61089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772"/>
                </a:spcAft>
              </a:pPr>
              <a:r>
                <a:rPr lang="en-US" sz="1488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Pellet</a:t>
              </a:r>
              <a:endParaRPr lang="en-US" sz="1488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71">
              <a:extLst>
                <a:ext uri="{FF2B5EF4-FFF2-40B4-BE49-F238E27FC236}">
                  <a16:creationId xmlns:a16="http://schemas.microsoft.com/office/drawing/2014/main" id="{4AA34B8A-861B-049D-C326-CFC0D6BB98D0}"/>
                </a:ext>
              </a:extLst>
            </p:cNvPr>
            <p:cNvSpPr txBox="1"/>
            <p:nvPr/>
          </p:nvSpPr>
          <p:spPr>
            <a:xfrm rot="16200000">
              <a:off x="2981332" y="48205"/>
              <a:ext cx="1521835" cy="71138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772"/>
                </a:spcAft>
              </a:pPr>
              <a:r>
                <a:rPr lang="en-US" sz="1488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Supernatant</a:t>
              </a:r>
              <a:endParaRPr lang="en-US" sz="1488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74">
              <a:extLst>
                <a:ext uri="{FF2B5EF4-FFF2-40B4-BE49-F238E27FC236}">
                  <a16:creationId xmlns:a16="http://schemas.microsoft.com/office/drawing/2014/main" id="{F1374F55-FF97-76D6-E1E6-508B0E5CF499}"/>
                </a:ext>
              </a:extLst>
            </p:cNvPr>
            <p:cNvSpPr txBox="1"/>
            <p:nvPr/>
          </p:nvSpPr>
          <p:spPr>
            <a:xfrm>
              <a:off x="3919456" y="1351049"/>
              <a:ext cx="1197967" cy="449128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772"/>
                </a:spcAft>
              </a:pPr>
              <a:r>
                <a:rPr lang="en-US" sz="1488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38kD</a:t>
              </a:r>
              <a:endParaRPr lang="en-US" sz="1488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6">
              <a:extLst>
                <a:ext uri="{FF2B5EF4-FFF2-40B4-BE49-F238E27FC236}">
                  <a16:creationId xmlns:a16="http://schemas.microsoft.com/office/drawing/2014/main" id="{43AA6EC5-CE6C-D075-D1EB-6D4E6BB44F25}"/>
                </a:ext>
              </a:extLst>
            </p:cNvPr>
            <p:cNvSpPr txBox="1"/>
            <p:nvPr/>
          </p:nvSpPr>
          <p:spPr>
            <a:xfrm>
              <a:off x="3923957" y="2545280"/>
              <a:ext cx="1131490" cy="449128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772"/>
                </a:spcAft>
              </a:pPr>
              <a:r>
                <a:rPr lang="en-US" sz="1488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38kD</a:t>
              </a:r>
              <a:endParaRPr lang="en-US" sz="1488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78">
              <a:extLst>
                <a:ext uri="{FF2B5EF4-FFF2-40B4-BE49-F238E27FC236}">
                  <a16:creationId xmlns:a16="http://schemas.microsoft.com/office/drawing/2014/main" id="{D6E238BA-BFB4-AFD2-8B5A-FB434A670F13}"/>
                </a:ext>
              </a:extLst>
            </p:cNvPr>
            <p:cNvSpPr txBox="1"/>
            <p:nvPr/>
          </p:nvSpPr>
          <p:spPr>
            <a:xfrm>
              <a:off x="0" y="2684970"/>
              <a:ext cx="2455790" cy="64936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>
                <a:lnSpc>
                  <a:spcPct val="107000"/>
                </a:lnSpc>
                <a:spcAft>
                  <a:spcPts val="772"/>
                </a:spcAft>
              </a:pPr>
              <a:r>
                <a:rPr lang="en-US" sz="1488" i="1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∆</a:t>
              </a:r>
              <a:r>
                <a:rPr lang="en-US" sz="1488" i="1" dirty="0" err="1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hrcC</a:t>
              </a:r>
              <a:r>
                <a:rPr lang="en-US" sz="1488" i="1" baseline="30000" dirty="0" err="1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GMI</a:t>
              </a:r>
              <a:r>
                <a:rPr lang="en-US" sz="1488" i="1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+ </a:t>
              </a:r>
              <a:r>
                <a:rPr lang="en-US" sz="1488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RipU</a:t>
              </a:r>
              <a:r>
                <a:rPr lang="en-US" sz="1488" i="1" baseline="300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K60</a:t>
              </a:r>
              <a:endParaRPr lang="en-US" sz="1488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79">
              <a:extLst>
                <a:ext uri="{FF2B5EF4-FFF2-40B4-BE49-F238E27FC236}">
                  <a16:creationId xmlns:a16="http://schemas.microsoft.com/office/drawing/2014/main" id="{A2AED408-EB38-041A-F807-A774ECB7267B}"/>
                </a:ext>
              </a:extLst>
            </p:cNvPr>
            <p:cNvSpPr txBox="1"/>
            <p:nvPr/>
          </p:nvSpPr>
          <p:spPr>
            <a:xfrm>
              <a:off x="-71396" y="1505173"/>
              <a:ext cx="2528308" cy="822928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>
                <a:lnSpc>
                  <a:spcPct val="107000"/>
                </a:lnSpc>
                <a:spcAft>
                  <a:spcPts val="772"/>
                </a:spcAft>
              </a:pPr>
              <a:r>
                <a:rPr lang="en-US" sz="1488" i="1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Rp GMI1000</a:t>
              </a:r>
              <a:r>
                <a:rPr lang="en-US" sz="1488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+ RipU</a:t>
              </a:r>
              <a:r>
                <a:rPr lang="en-US" sz="1488" baseline="300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K60</a:t>
              </a:r>
              <a:endParaRPr lang="en-US" sz="1488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" name="Text Box 2">
            <a:extLst>
              <a:ext uri="{FF2B5EF4-FFF2-40B4-BE49-F238E27FC236}">
                <a16:creationId xmlns:a16="http://schemas.microsoft.com/office/drawing/2014/main" id="{1CF30E57-C01C-64B8-CE02-ED9D2F63408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0560" y="5551279"/>
            <a:ext cx="6976166" cy="974923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7155" tIns="48578" rIns="97155" bIns="48578" anchor="t" anchorCtr="0">
            <a:noAutofit/>
          </a:bodyPr>
          <a:lstStyle/>
          <a:p>
            <a:pPr algn="just">
              <a:lnSpc>
                <a:spcPct val="107000"/>
              </a:lnSpc>
              <a:spcAft>
                <a:spcPts val="850"/>
              </a:spcAft>
            </a:pPr>
            <a:r>
              <a:rPr lang="en-US" sz="1275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 1.</a:t>
            </a:r>
            <a:r>
              <a:rPr lang="en-US" sz="1275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75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ipU is secreted through the type III secretion system. </a:t>
            </a:r>
            <a:r>
              <a:rPr lang="en-US" sz="1275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munoblots with RipU</a:t>
            </a:r>
            <a:r>
              <a:rPr lang="en-US" sz="1275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60</a:t>
            </a:r>
            <a:r>
              <a:rPr lang="en-US" sz="1275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agged with HA detected in (A) both the supernatant and pellet of </a:t>
            </a:r>
            <a:r>
              <a:rPr lang="en-US" sz="1275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p</a:t>
            </a:r>
            <a:r>
              <a:rPr lang="en-US" sz="1275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MI1000 and (B) only in the pellet of </a:t>
            </a:r>
            <a:r>
              <a:rPr lang="en-US" sz="1275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∆</a:t>
            </a:r>
            <a:r>
              <a:rPr lang="en-US" sz="1275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rcC</a:t>
            </a:r>
            <a:r>
              <a:rPr lang="en-US" sz="1275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utant (RipU + HA tag =  ~38kDa). </a:t>
            </a:r>
            <a:endParaRPr lang="en-US" sz="17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4951D64-2263-BF41-016F-127652711105}"/>
              </a:ext>
            </a:extLst>
          </p:cNvPr>
          <p:cNvSpPr txBox="1"/>
          <p:nvPr/>
        </p:nvSpPr>
        <p:spPr>
          <a:xfrm>
            <a:off x="3115158" y="2231430"/>
            <a:ext cx="399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1DF1EAB-11FE-C4F6-E3D8-AAA3D17678D5}"/>
              </a:ext>
            </a:extLst>
          </p:cNvPr>
          <p:cNvSpPr txBox="1"/>
          <p:nvPr/>
        </p:nvSpPr>
        <p:spPr>
          <a:xfrm>
            <a:off x="3136039" y="3569183"/>
            <a:ext cx="399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9412613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0470</TotalTime>
  <Words>68</Words>
  <Application>Microsoft Macintosh PowerPoint</Application>
  <PresentationFormat>Custom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bie Rogers</dc:creator>
  <cp:lastModifiedBy>Iyer-Pascuzzi, Anjali</cp:lastModifiedBy>
  <cp:revision>91</cp:revision>
  <cp:lastPrinted>2023-08-11T15:56:49Z</cp:lastPrinted>
  <dcterms:created xsi:type="dcterms:W3CDTF">2023-07-31T18:29:50Z</dcterms:created>
  <dcterms:modified xsi:type="dcterms:W3CDTF">2023-10-31T18:19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4044bd30-2ed7-4c9d-9d12-46200872a97b_Enabled">
    <vt:lpwstr>true</vt:lpwstr>
  </property>
  <property fmtid="{D5CDD505-2E9C-101B-9397-08002B2CF9AE}" pid="3" name="MSIP_Label_4044bd30-2ed7-4c9d-9d12-46200872a97b_SetDate">
    <vt:lpwstr>2023-09-14T20:27:40Z</vt:lpwstr>
  </property>
  <property fmtid="{D5CDD505-2E9C-101B-9397-08002B2CF9AE}" pid="4" name="MSIP_Label_4044bd30-2ed7-4c9d-9d12-46200872a97b_Method">
    <vt:lpwstr>Standard</vt:lpwstr>
  </property>
  <property fmtid="{D5CDD505-2E9C-101B-9397-08002B2CF9AE}" pid="5" name="MSIP_Label_4044bd30-2ed7-4c9d-9d12-46200872a97b_Name">
    <vt:lpwstr>defa4170-0d19-0005-0004-bc88714345d2</vt:lpwstr>
  </property>
  <property fmtid="{D5CDD505-2E9C-101B-9397-08002B2CF9AE}" pid="6" name="MSIP_Label_4044bd30-2ed7-4c9d-9d12-46200872a97b_SiteId">
    <vt:lpwstr>4130bd39-7c53-419c-b1e5-8758d6d63f21</vt:lpwstr>
  </property>
  <property fmtid="{D5CDD505-2E9C-101B-9397-08002B2CF9AE}" pid="7" name="MSIP_Label_4044bd30-2ed7-4c9d-9d12-46200872a97b_ActionId">
    <vt:lpwstr>4ed88b01-9c6f-4a5d-b612-ada5748b513a</vt:lpwstr>
  </property>
  <property fmtid="{D5CDD505-2E9C-101B-9397-08002B2CF9AE}" pid="8" name="MSIP_Label_4044bd30-2ed7-4c9d-9d12-46200872a97b_ContentBits">
    <vt:lpwstr>0</vt:lpwstr>
  </property>
</Properties>
</file>